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AF0BBE-0355-4A85-90E8-9B1BF18187A5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EB000F-D928-47A5-8027-5B16F167ACB8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4FBAD-FD3A-4ED9-909D-988D96B263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6976D-6FEB-4BD4-9AFA-79DE185FC0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18D64F-1544-4E48-957F-C390A88A82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1059CF-5214-4A51-BE15-8502C6682F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8A114-F2D5-46B0-8E1E-7ED375EE21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741FE3-E0DC-418E-BBD4-7CF4D54E20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ECCBBB-79BA-4165-9EBD-040E9026F7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CE40C-82EA-4703-AF4C-8BBC2159C2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9652DA-B558-4195-A09A-FBC861AF49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C7F1AC-874B-49AB-A6F7-2250BD7B68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86C5A-95BC-4483-A160-D32C150960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BE333-2024-4B0C-9B0D-B7B4DD7CF5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A40104-2E65-4AF5-89B6-B5A9369FCC85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303120" y="790560"/>
          <a:ext cx="3035520" cy="4064040"/>
        </p:xfrm>
        <a:graphic>
          <a:graphicData uri="http://schemas.openxmlformats.org/drawingml/2006/table">
            <a:tbl>
              <a:tblPr/>
              <a:tblGrid>
                <a:gridCol w="287280"/>
                <a:gridCol w="173160"/>
                <a:gridCol w="171360"/>
                <a:gridCol w="171720"/>
                <a:gridCol w="171360"/>
                <a:gridCol w="171360"/>
                <a:gridCol w="171360"/>
                <a:gridCol w="171720"/>
                <a:gridCol w="172800"/>
                <a:gridCol w="171360"/>
                <a:gridCol w="171720"/>
                <a:gridCol w="171360"/>
                <a:gridCol w="171360"/>
                <a:gridCol w="171360"/>
                <a:gridCol w="171720"/>
                <a:gridCol w="172800"/>
                <a:gridCol w="171720"/>
              </a:tblGrid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3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7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66ff33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8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66ff33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19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66ff33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20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66ff33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21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66ff33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CasellaDiTesto 12"/>
          <p:cNvSpPr/>
          <p:nvPr/>
        </p:nvSpPr>
        <p:spPr>
          <a:xfrm>
            <a:off x="3448080" y="1903320"/>
            <a:ext cx="5651640" cy="204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Supplementary Figure 2: </a:t>
            </a:r>
            <a:r>
              <a:rPr b="0" lang="it-IT" sz="1600" spc="-1" strike="noStrike" u="sng">
                <a:solidFill>
                  <a:srgbClr val="000000"/>
                </a:solidFill>
                <a:uFillTx/>
                <a:latin typeface="Calibri"/>
              </a:rPr>
              <a:t>Pooling strateg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In the strategy used, sixteen detector pools (P1-P16, in yellow) of five different samples were created. Other five scout pools (P17s-P21s, in green) of sixteen samples (one from each of the detector pools) were then created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The detector pools were useful to correctly analyze the data and call the variations; the scout pools were needed to assign each variation to a specific sample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5T11:06:11Z</dcterms:created>
  <dc:creator>LabN</dc:creator>
  <dc:description/>
  <dc:language>en-US</dc:language>
  <cp:lastModifiedBy>LabN</cp:lastModifiedBy>
  <dcterms:modified xsi:type="dcterms:W3CDTF">2014-07-30T11:54:32Z</dcterms:modified>
  <cp:revision>10</cp:revision>
  <dc:subject/>
  <dc:title>Diapositiva 1</dc:title>
</cp:coreProperties>
</file>